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670675" cy="9928225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379516B-CE23-4D78-9CDC-73E654BFAD7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C7AF98F-CE33-440F-AF47-58B1B8D30696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4CEBDFD-2ACC-4101-980D-E747162A923C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AA303B-C6F7-438F-87F1-D06D2C025EB1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CC5C542-C24E-4FF2-8EDD-FC12807766D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D935F9D-0CFB-4C6E-9938-82EFE7234D5B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1941ADA-D773-4A14-9B41-338EB4836DB8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00DE97-D006-4D18-ADD3-E844E76DDE3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9061D6E-582A-463F-8AD8-8F885891838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8302D6-3EF5-43DB-B7F3-B5238A42E8B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0FAA3-C20E-4828-8B00-DA63EE5C6EE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11DD517-51BA-4879-A14A-2926F0C6424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182160"/>
            <a:ext cx="217152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182160"/>
            <a:ext cx="1600200" cy="527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GB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DA1D91F5-109D-4FA4-B5D1-310D4D479FD4}" type="slidenum">
              <a:rPr b="0" lang="en-GB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115920" y="974880"/>
          <a:ext cx="6553080" cy="2995560"/>
        </p:xfrm>
        <a:graphic>
          <a:graphicData uri="http://schemas.openxmlformats.org/drawingml/2006/table">
            <a:tbl>
              <a:tblPr/>
              <a:tblGrid>
                <a:gridCol w="2095560"/>
                <a:gridCol w="1236600"/>
                <a:gridCol w="912960"/>
                <a:gridCol w="296640"/>
                <a:gridCol w="1663920"/>
                <a:gridCol w="347400"/>
              </a:tblGrid>
              <a:tr h="30924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inical-pathological paramet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ivariate analy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ltivariate analy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685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e (n=10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759 (0.751, 4.12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9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-stage (n=10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626 (1.533, 8.57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377 (0.933, 6.058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ymph-node involvemen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546 (0.556, 4.296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mour-Grad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02 (0.463, 3.66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17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720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strogen receptor stat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33 (0.392, 2.21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7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75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clear KIF20A sco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008 (1.334, 12.04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147 (1.001, 9.891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18576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2520"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2" name="TextBox 4"/>
          <p:cNvSpPr/>
          <p:nvPr/>
        </p:nvSpPr>
        <p:spPr>
          <a:xfrm>
            <a:off x="108720" y="115920"/>
            <a:ext cx="4405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Patients who have received chemotherapy (n=60)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115920" y="4435560"/>
          <a:ext cx="6553080" cy="2700360"/>
        </p:xfrm>
        <a:graphic>
          <a:graphicData uri="http://schemas.openxmlformats.org/drawingml/2006/table">
            <a:tbl>
              <a:tblPr/>
              <a:tblGrid>
                <a:gridCol w="2158920"/>
                <a:gridCol w="1416240"/>
                <a:gridCol w="353880"/>
                <a:gridCol w="576360"/>
                <a:gridCol w="1385640"/>
                <a:gridCol w="576360"/>
                <a:gridCol w="85680"/>
              </a:tblGrid>
              <a:tr h="33948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linical-pathological parameter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ivariate analy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ultivariate analysi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R (95% CI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ge (n=10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382 (0.551, 3.468)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9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252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-stage (n=10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3.579 (1.446, 8.86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6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2.169 (0.811, 5.80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1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8252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Lymph-node involvement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934 (0.636, 5.880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245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872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umour-Grade 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211 (0.426, 3.445)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2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980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strogen receptor status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56 (0.384, 2.381)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923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1983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  <a:tr h="200160"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uclear KIF20A score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5.089 (1.467, 17.657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8640" rIns="8640" tIns="936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10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8640" marR="864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24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4.108 (1.135, 14.873)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31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360" rIns="9360" tIns="10080" bIns="0" anchor="b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en-US" sz="10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 </a:t>
                      </a:r>
                      <a:endParaRPr b="0" lang="en-US" sz="10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b" marL="9360" marR="9360">
                    <a:lnL w="5760">
                      <a:solidFill>
                        <a:srgbClr val="ffffff"/>
                      </a:solidFill>
                    </a:lnL>
                    <a:lnR w="5760">
                      <a:solidFill>
                        <a:srgbClr val="ffffff"/>
                      </a:solidFill>
                    </a:lnR>
                    <a:lnT w="5760">
                      <a:solidFill>
                        <a:srgbClr val="ffffff"/>
                      </a:solidFill>
                    </a:lnT>
                    <a:lnB w="5760">
                      <a:solidFill>
                        <a:srgbClr val="ffffff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TextBox 1"/>
          <p:cNvSpPr/>
          <p:nvPr/>
        </p:nvSpPr>
        <p:spPr>
          <a:xfrm>
            <a:off x="95760" y="563400"/>
            <a:ext cx="15631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Overall survival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5" name="TextBox 6"/>
          <p:cNvSpPr/>
          <p:nvPr/>
        </p:nvSpPr>
        <p:spPr>
          <a:xfrm>
            <a:off x="99360" y="4073400"/>
            <a:ext cx="235404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Disease-specific survival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TextBox 7"/>
          <p:cNvSpPr/>
          <p:nvPr/>
        </p:nvSpPr>
        <p:spPr>
          <a:xfrm>
            <a:off x="4599720" y="9510840"/>
            <a:ext cx="2108520" cy="2764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S13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47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4-12-10T13:30:06Z</dcterms:created>
  <dc:creator>Khongkow, Pasarat</dc:creator>
  <dc:description/>
  <dc:language>en-US</dc:language>
  <cp:lastModifiedBy>Eric Lam</cp:lastModifiedBy>
  <cp:lastPrinted>2015-04-01T15:47:29Z</cp:lastPrinted>
  <dcterms:modified xsi:type="dcterms:W3CDTF">2015-04-01T21:03:38Z</dcterms:modified>
  <cp:revision>105</cp:revision>
  <dc:subject/>
  <dc:title>PowerPoint Presentation</dc:title>
</cp:coreProperties>
</file>